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6" r:id="rId2"/>
  </p:sldIdLst>
  <p:sldSz cx="6551613" cy="59039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60" userDrawn="1">
          <p15:clr>
            <a:srgbClr val="A4A3A4"/>
          </p15:clr>
        </p15:guide>
        <p15:guide id="2" pos="20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1738" y="62"/>
      </p:cViewPr>
      <p:guideLst>
        <p:guide orient="horz" pos="1860"/>
        <p:guide pos="20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1371" y="966220"/>
            <a:ext cx="5568871" cy="2055436"/>
          </a:xfrm>
        </p:spPr>
        <p:txBody>
          <a:bodyPr anchor="b"/>
          <a:lstStyle>
            <a:lvl1pPr algn="ctr">
              <a:defRPr sz="429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8952" y="3100921"/>
            <a:ext cx="4913710" cy="1425412"/>
          </a:xfrm>
        </p:spPr>
        <p:txBody>
          <a:bodyPr/>
          <a:lstStyle>
            <a:lvl1pPr marL="0" indent="0" algn="ctr">
              <a:buNone/>
              <a:defRPr sz="1720"/>
            </a:lvl1pPr>
            <a:lvl2pPr marL="327584" indent="0" algn="ctr">
              <a:buNone/>
              <a:defRPr sz="1433"/>
            </a:lvl2pPr>
            <a:lvl3pPr marL="655168" indent="0" algn="ctr">
              <a:buNone/>
              <a:defRPr sz="1290"/>
            </a:lvl3pPr>
            <a:lvl4pPr marL="982751" indent="0" algn="ctr">
              <a:buNone/>
              <a:defRPr sz="1146"/>
            </a:lvl4pPr>
            <a:lvl5pPr marL="1310335" indent="0" algn="ctr">
              <a:buNone/>
              <a:defRPr sz="1146"/>
            </a:lvl5pPr>
            <a:lvl6pPr marL="1637919" indent="0" algn="ctr">
              <a:buNone/>
              <a:defRPr sz="1146"/>
            </a:lvl6pPr>
            <a:lvl7pPr marL="1965503" indent="0" algn="ctr">
              <a:buNone/>
              <a:defRPr sz="1146"/>
            </a:lvl7pPr>
            <a:lvl8pPr marL="2293087" indent="0" algn="ctr">
              <a:buNone/>
              <a:defRPr sz="1146"/>
            </a:lvl8pPr>
            <a:lvl9pPr marL="2620670" indent="0" algn="ctr">
              <a:buNone/>
              <a:defRPr sz="1146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714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1177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88498" y="314329"/>
            <a:ext cx="1412692" cy="500329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0424" y="314329"/>
            <a:ext cx="4156179" cy="5003293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7787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092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012" y="1471880"/>
            <a:ext cx="5650766" cy="2455863"/>
          </a:xfrm>
        </p:spPr>
        <p:txBody>
          <a:bodyPr anchor="b"/>
          <a:lstStyle>
            <a:lvl1pPr>
              <a:defRPr sz="4299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012" y="3950977"/>
            <a:ext cx="5650766" cy="1291481"/>
          </a:xfrm>
        </p:spPr>
        <p:txBody>
          <a:bodyPr/>
          <a:lstStyle>
            <a:lvl1pPr marL="0" indent="0">
              <a:buNone/>
              <a:defRPr sz="1720">
                <a:solidFill>
                  <a:schemeClr val="tx1"/>
                </a:solidFill>
              </a:defRPr>
            </a:lvl1pPr>
            <a:lvl2pPr marL="327584" indent="0">
              <a:buNone/>
              <a:defRPr sz="1433">
                <a:solidFill>
                  <a:schemeClr val="tx1">
                    <a:tint val="75000"/>
                  </a:schemeClr>
                </a:solidFill>
              </a:defRPr>
            </a:lvl2pPr>
            <a:lvl3pPr marL="655168" indent="0">
              <a:buNone/>
              <a:defRPr sz="1290">
                <a:solidFill>
                  <a:schemeClr val="tx1">
                    <a:tint val="75000"/>
                  </a:schemeClr>
                </a:solidFill>
              </a:defRPr>
            </a:lvl3pPr>
            <a:lvl4pPr marL="982751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4pPr>
            <a:lvl5pPr marL="1310335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5pPr>
            <a:lvl6pPr marL="1637919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6pPr>
            <a:lvl7pPr marL="1965503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7pPr>
            <a:lvl8pPr marL="2293087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8pPr>
            <a:lvl9pPr marL="2620670" indent="0">
              <a:buNone/>
              <a:defRPr sz="11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285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0423" y="1571643"/>
            <a:ext cx="2784436" cy="374597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16754" y="1571643"/>
            <a:ext cx="2784436" cy="3745979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9687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1277" y="314330"/>
            <a:ext cx="5650766" cy="114115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1277" y="1447279"/>
            <a:ext cx="2771639" cy="709289"/>
          </a:xfrm>
        </p:spPr>
        <p:txBody>
          <a:bodyPr anchor="b"/>
          <a:lstStyle>
            <a:lvl1pPr marL="0" indent="0">
              <a:buNone/>
              <a:defRPr sz="1720" b="1"/>
            </a:lvl1pPr>
            <a:lvl2pPr marL="327584" indent="0">
              <a:buNone/>
              <a:defRPr sz="1433" b="1"/>
            </a:lvl2pPr>
            <a:lvl3pPr marL="655168" indent="0">
              <a:buNone/>
              <a:defRPr sz="1290" b="1"/>
            </a:lvl3pPr>
            <a:lvl4pPr marL="982751" indent="0">
              <a:buNone/>
              <a:defRPr sz="1146" b="1"/>
            </a:lvl4pPr>
            <a:lvl5pPr marL="1310335" indent="0">
              <a:buNone/>
              <a:defRPr sz="1146" b="1"/>
            </a:lvl5pPr>
            <a:lvl6pPr marL="1637919" indent="0">
              <a:buNone/>
              <a:defRPr sz="1146" b="1"/>
            </a:lvl6pPr>
            <a:lvl7pPr marL="1965503" indent="0">
              <a:buNone/>
              <a:defRPr sz="1146" b="1"/>
            </a:lvl7pPr>
            <a:lvl8pPr marL="2293087" indent="0">
              <a:buNone/>
              <a:defRPr sz="1146" b="1"/>
            </a:lvl8pPr>
            <a:lvl9pPr marL="2620670" indent="0">
              <a:buNone/>
              <a:defRPr sz="1146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1277" y="2156568"/>
            <a:ext cx="2771639" cy="317198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16754" y="1447279"/>
            <a:ext cx="2785289" cy="709289"/>
          </a:xfrm>
        </p:spPr>
        <p:txBody>
          <a:bodyPr anchor="b"/>
          <a:lstStyle>
            <a:lvl1pPr marL="0" indent="0">
              <a:buNone/>
              <a:defRPr sz="1720" b="1"/>
            </a:lvl1pPr>
            <a:lvl2pPr marL="327584" indent="0">
              <a:buNone/>
              <a:defRPr sz="1433" b="1"/>
            </a:lvl2pPr>
            <a:lvl3pPr marL="655168" indent="0">
              <a:buNone/>
              <a:defRPr sz="1290" b="1"/>
            </a:lvl3pPr>
            <a:lvl4pPr marL="982751" indent="0">
              <a:buNone/>
              <a:defRPr sz="1146" b="1"/>
            </a:lvl4pPr>
            <a:lvl5pPr marL="1310335" indent="0">
              <a:buNone/>
              <a:defRPr sz="1146" b="1"/>
            </a:lvl5pPr>
            <a:lvl6pPr marL="1637919" indent="0">
              <a:buNone/>
              <a:defRPr sz="1146" b="1"/>
            </a:lvl6pPr>
            <a:lvl7pPr marL="1965503" indent="0">
              <a:buNone/>
              <a:defRPr sz="1146" b="1"/>
            </a:lvl7pPr>
            <a:lvl8pPr marL="2293087" indent="0">
              <a:buNone/>
              <a:defRPr sz="1146" b="1"/>
            </a:lvl8pPr>
            <a:lvl9pPr marL="2620670" indent="0">
              <a:buNone/>
              <a:defRPr sz="1146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16754" y="2156568"/>
            <a:ext cx="2785289" cy="3171987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5086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20257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3146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1277" y="393594"/>
            <a:ext cx="2113066" cy="1377580"/>
          </a:xfrm>
        </p:spPr>
        <p:txBody>
          <a:bodyPr anchor="b"/>
          <a:lstStyle>
            <a:lvl1pPr>
              <a:defRPr sz="229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85289" y="850055"/>
            <a:ext cx="3316754" cy="4195605"/>
          </a:xfrm>
        </p:spPr>
        <p:txBody>
          <a:bodyPr/>
          <a:lstStyle>
            <a:lvl1pPr>
              <a:defRPr sz="2293"/>
            </a:lvl1pPr>
            <a:lvl2pPr>
              <a:defRPr sz="2006"/>
            </a:lvl2pPr>
            <a:lvl3pPr>
              <a:defRPr sz="1720"/>
            </a:lvl3pPr>
            <a:lvl4pPr>
              <a:defRPr sz="1433"/>
            </a:lvl4pPr>
            <a:lvl5pPr>
              <a:defRPr sz="1433"/>
            </a:lvl5pPr>
            <a:lvl6pPr>
              <a:defRPr sz="1433"/>
            </a:lvl6pPr>
            <a:lvl7pPr>
              <a:defRPr sz="1433"/>
            </a:lvl7pPr>
            <a:lvl8pPr>
              <a:defRPr sz="1433"/>
            </a:lvl8pPr>
            <a:lvl9pPr>
              <a:defRPr sz="1433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1277" y="1771174"/>
            <a:ext cx="2113066" cy="3281319"/>
          </a:xfrm>
        </p:spPr>
        <p:txBody>
          <a:bodyPr/>
          <a:lstStyle>
            <a:lvl1pPr marL="0" indent="0">
              <a:buNone/>
              <a:defRPr sz="1146"/>
            </a:lvl1pPr>
            <a:lvl2pPr marL="327584" indent="0">
              <a:buNone/>
              <a:defRPr sz="1003"/>
            </a:lvl2pPr>
            <a:lvl3pPr marL="655168" indent="0">
              <a:buNone/>
              <a:defRPr sz="860"/>
            </a:lvl3pPr>
            <a:lvl4pPr marL="982751" indent="0">
              <a:buNone/>
              <a:defRPr sz="717"/>
            </a:lvl4pPr>
            <a:lvl5pPr marL="1310335" indent="0">
              <a:buNone/>
              <a:defRPr sz="717"/>
            </a:lvl5pPr>
            <a:lvl6pPr marL="1637919" indent="0">
              <a:buNone/>
              <a:defRPr sz="717"/>
            </a:lvl6pPr>
            <a:lvl7pPr marL="1965503" indent="0">
              <a:buNone/>
              <a:defRPr sz="717"/>
            </a:lvl7pPr>
            <a:lvl8pPr marL="2293087" indent="0">
              <a:buNone/>
              <a:defRPr sz="717"/>
            </a:lvl8pPr>
            <a:lvl9pPr marL="2620670" indent="0">
              <a:buNone/>
              <a:defRPr sz="71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58228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1277" y="393594"/>
            <a:ext cx="2113066" cy="1377580"/>
          </a:xfrm>
        </p:spPr>
        <p:txBody>
          <a:bodyPr anchor="b"/>
          <a:lstStyle>
            <a:lvl1pPr>
              <a:defRPr sz="2293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85289" y="850055"/>
            <a:ext cx="3316754" cy="4195605"/>
          </a:xfrm>
        </p:spPr>
        <p:txBody>
          <a:bodyPr anchor="t"/>
          <a:lstStyle>
            <a:lvl1pPr marL="0" indent="0">
              <a:buNone/>
              <a:defRPr sz="2293"/>
            </a:lvl1pPr>
            <a:lvl2pPr marL="327584" indent="0">
              <a:buNone/>
              <a:defRPr sz="2006"/>
            </a:lvl2pPr>
            <a:lvl3pPr marL="655168" indent="0">
              <a:buNone/>
              <a:defRPr sz="1720"/>
            </a:lvl3pPr>
            <a:lvl4pPr marL="982751" indent="0">
              <a:buNone/>
              <a:defRPr sz="1433"/>
            </a:lvl4pPr>
            <a:lvl5pPr marL="1310335" indent="0">
              <a:buNone/>
              <a:defRPr sz="1433"/>
            </a:lvl5pPr>
            <a:lvl6pPr marL="1637919" indent="0">
              <a:buNone/>
              <a:defRPr sz="1433"/>
            </a:lvl6pPr>
            <a:lvl7pPr marL="1965503" indent="0">
              <a:buNone/>
              <a:defRPr sz="1433"/>
            </a:lvl7pPr>
            <a:lvl8pPr marL="2293087" indent="0">
              <a:buNone/>
              <a:defRPr sz="1433"/>
            </a:lvl8pPr>
            <a:lvl9pPr marL="2620670" indent="0">
              <a:buNone/>
              <a:defRPr sz="1433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1277" y="1771174"/>
            <a:ext cx="2113066" cy="3281319"/>
          </a:xfrm>
        </p:spPr>
        <p:txBody>
          <a:bodyPr/>
          <a:lstStyle>
            <a:lvl1pPr marL="0" indent="0">
              <a:buNone/>
              <a:defRPr sz="1146"/>
            </a:lvl1pPr>
            <a:lvl2pPr marL="327584" indent="0">
              <a:buNone/>
              <a:defRPr sz="1003"/>
            </a:lvl2pPr>
            <a:lvl3pPr marL="655168" indent="0">
              <a:buNone/>
              <a:defRPr sz="860"/>
            </a:lvl3pPr>
            <a:lvl4pPr marL="982751" indent="0">
              <a:buNone/>
              <a:defRPr sz="717"/>
            </a:lvl4pPr>
            <a:lvl5pPr marL="1310335" indent="0">
              <a:buNone/>
              <a:defRPr sz="717"/>
            </a:lvl5pPr>
            <a:lvl6pPr marL="1637919" indent="0">
              <a:buNone/>
              <a:defRPr sz="717"/>
            </a:lvl6pPr>
            <a:lvl7pPr marL="1965503" indent="0">
              <a:buNone/>
              <a:defRPr sz="717"/>
            </a:lvl7pPr>
            <a:lvl8pPr marL="2293087" indent="0">
              <a:buNone/>
              <a:defRPr sz="717"/>
            </a:lvl8pPr>
            <a:lvl9pPr marL="2620670" indent="0">
              <a:buNone/>
              <a:defRPr sz="717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2333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0424" y="314330"/>
            <a:ext cx="5650766" cy="11411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424" y="1571643"/>
            <a:ext cx="5650766" cy="37459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0423" y="5472054"/>
            <a:ext cx="1474113" cy="3143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7E899-F63A-40CA-B775-C62C3D56765B}" type="datetimeFigureOut">
              <a:rPr lang="zh-CN" altLang="en-US" smtClean="0"/>
              <a:t>2023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70222" y="5472054"/>
            <a:ext cx="2211169" cy="3143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27077" y="5472054"/>
            <a:ext cx="1474113" cy="31432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45173-C686-4333-B01D-17D76E39F2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3648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55168" rtl="0" eaLnBrk="1" latinLnBrk="0" hangingPunct="1">
        <a:lnSpc>
          <a:spcPct val="90000"/>
        </a:lnSpc>
        <a:spcBef>
          <a:spcPct val="0"/>
        </a:spcBef>
        <a:buNone/>
        <a:defRPr sz="31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3792" indent="-163792" algn="l" defTabSz="655168" rtl="0" eaLnBrk="1" latinLnBrk="0" hangingPunct="1">
        <a:lnSpc>
          <a:spcPct val="90000"/>
        </a:lnSpc>
        <a:spcBef>
          <a:spcPts val="717"/>
        </a:spcBef>
        <a:buFont typeface="Arial" panose="020B0604020202020204" pitchFamily="34" charset="0"/>
        <a:buChar char="•"/>
        <a:defRPr sz="2006" kern="1200">
          <a:solidFill>
            <a:schemeClr val="tx1"/>
          </a:solidFill>
          <a:latin typeface="+mn-lt"/>
          <a:ea typeface="+mn-ea"/>
          <a:cs typeface="+mn-cs"/>
        </a:defRPr>
      </a:lvl1pPr>
      <a:lvl2pPr marL="491376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720" kern="1200">
          <a:solidFill>
            <a:schemeClr val="tx1"/>
          </a:solidFill>
          <a:latin typeface="+mn-lt"/>
          <a:ea typeface="+mn-ea"/>
          <a:cs typeface="+mn-cs"/>
        </a:defRPr>
      </a:lvl2pPr>
      <a:lvl3pPr marL="818960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433" kern="1200">
          <a:solidFill>
            <a:schemeClr val="tx1"/>
          </a:solidFill>
          <a:latin typeface="+mn-lt"/>
          <a:ea typeface="+mn-ea"/>
          <a:cs typeface="+mn-cs"/>
        </a:defRPr>
      </a:lvl3pPr>
      <a:lvl4pPr marL="1146543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290" kern="1200">
          <a:solidFill>
            <a:schemeClr val="tx1"/>
          </a:solidFill>
          <a:latin typeface="+mn-lt"/>
          <a:ea typeface="+mn-ea"/>
          <a:cs typeface="+mn-cs"/>
        </a:defRPr>
      </a:lvl4pPr>
      <a:lvl5pPr marL="1474127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290" kern="1200">
          <a:solidFill>
            <a:schemeClr val="tx1"/>
          </a:solidFill>
          <a:latin typeface="+mn-lt"/>
          <a:ea typeface="+mn-ea"/>
          <a:cs typeface="+mn-cs"/>
        </a:defRPr>
      </a:lvl5pPr>
      <a:lvl6pPr marL="1801711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290" kern="1200">
          <a:solidFill>
            <a:schemeClr val="tx1"/>
          </a:solidFill>
          <a:latin typeface="+mn-lt"/>
          <a:ea typeface="+mn-ea"/>
          <a:cs typeface="+mn-cs"/>
        </a:defRPr>
      </a:lvl6pPr>
      <a:lvl7pPr marL="2129295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290" kern="1200">
          <a:solidFill>
            <a:schemeClr val="tx1"/>
          </a:solidFill>
          <a:latin typeface="+mn-lt"/>
          <a:ea typeface="+mn-ea"/>
          <a:cs typeface="+mn-cs"/>
        </a:defRPr>
      </a:lvl7pPr>
      <a:lvl8pPr marL="2456879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290" kern="1200">
          <a:solidFill>
            <a:schemeClr val="tx1"/>
          </a:solidFill>
          <a:latin typeface="+mn-lt"/>
          <a:ea typeface="+mn-ea"/>
          <a:cs typeface="+mn-cs"/>
        </a:defRPr>
      </a:lvl8pPr>
      <a:lvl9pPr marL="2784462" indent="-163792" algn="l" defTabSz="655168" rtl="0" eaLnBrk="1" latinLnBrk="0" hangingPunct="1">
        <a:lnSpc>
          <a:spcPct val="90000"/>
        </a:lnSpc>
        <a:spcBef>
          <a:spcPts val="358"/>
        </a:spcBef>
        <a:buFont typeface="Arial" panose="020B0604020202020204" pitchFamily="34" charset="0"/>
        <a:buChar char="•"/>
        <a:defRPr sz="12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1pPr>
      <a:lvl2pPr marL="327584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2pPr>
      <a:lvl3pPr marL="655168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3pPr>
      <a:lvl4pPr marL="982751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4pPr>
      <a:lvl5pPr marL="1310335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5pPr>
      <a:lvl6pPr marL="1637919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6pPr>
      <a:lvl7pPr marL="1965503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7pPr>
      <a:lvl8pPr marL="2293087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8pPr>
      <a:lvl9pPr marL="2620670" algn="l" defTabSz="655168" rtl="0" eaLnBrk="1" latinLnBrk="0" hangingPunct="1">
        <a:defRPr sz="12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组合 36"/>
          <p:cNvGrpSpPr/>
          <p:nvPr/>
        </p:nvGrpSpPr>
        <p:grpSpPr>
          <a:xfrm>
            <a:off x="16419" y="23072"/>
            <a:ext cx="6411460" cy="5840140"/>
            <a:chOff x="23853" y="86758"/>
            <a:chExt cx="6411460" cy="5840140"/>
          </a:xfrm>
        </p:grpSpPr>
        <p:sp>
          <p:nvSpPr>
            <p:cNvPr id="38" name="椭圆 37"/>
            <p:cNvSpPr/>
            <p:nvPr/>
          </p:nvSpPr>
          <p:spPr>
            <a:xfrm>
              <a:off x="2744509" y="86758"/>
              <a:ext cx="766354" cy="287383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Start</a:t>
              </a:r>
              <a:endParaRPr lang="zh-CN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39" name="圆角矩形 38"/>
            <p:cNvSpPr/>
            <p:nvPr/>
          </p:nvSpPr>
          <p:spPr>
            <a:xfrm>
              <a:off x="2026052" y="674710"/>
              <a:ext cx="2203269" cy="444137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Determine design variable and system output</a:t>
              </a:r>
              <a:endParaRPr lang="zh-CN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0" name="圆角矩形 39"/>
            <p:cNvSpPr/>
            <p:nvPr/>
          </p:nvSpPr>
          <p:spPr>
            <a:xfrm>
              <a:off x="2156680" y="1390518"/>
              <a:ext cx="1942013" cy="583195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Run OLHS</a:t>
              </a:r>
              <a:r>
                <a:rPr lang="zh-CN" altLang="en-US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and experiments to obtain training samples,</a:t>
              </a:r>
              <a:r>
                <a:rPr lang="zh-CN" altLang="en-US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(</a:t>
              </a:r>
              <a:r>
                <a:rPr lang="en-US" altLang="zh-CN" sz="12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X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, </a:t>
              </a:r>
              <a:r>
                <a:rPr lang="en-US" altLang="zh-CN" sz="12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y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)</a:t>
              </a:r>
              <a:endParaRPr lang="zh-CN" altLang="en-US" sz="1200" dirty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1" name="圆角矩形 40"/>
            <p:cNvSpPr/>
            <p:nvPr/>
          </p:nvSpPr>
          <p:spPr>
            <a:xfrm>
              <a:off x="65425" y="2347942"/>
              <a:ext cx="1858869" cy="5307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LOO-CV prediction of </a:t>
              </a:r>
              <a:r>
                <a:rPr lang="en-US" altLang="zh-CN" sz="12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</a:t>
              </a:r>
              <a:r>
                <a:rPr lang="en-US" altLang="zh-CN" sz="1200" baseline="30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th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model, </a:t>
              </a:r>
              <a:r>
                <a:rPr lang="en-US" altLang="zh-CN" sz="1200" b="1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y</a:t>
              </a:r>
              <a:r>
                <a:rPr lang="en-US" altLang="zh-CN" sz="1200" baseline="-25000" dirty="0" err="1" smtClean="0">
                  <a:solidFill>
                    <a:prstClr val="black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</a:t>
              </a:r>
              <a:r>
                <a:rPr lang="en-US" altLang="zh-CN" sz="1200" i="1" baseline="30000" dirty="0" smtClean="0">
                  <a:solidFill>
                    <a:prstClr val="black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-</a:t>
              </a:r>
              <a:endParaRPr lang="zh-CN" altLang="en-US" sz="1200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2" name="圆角矩形 41"/>
            <p:cNvSpPr/>
            <p:nvPr/>
          </p:nvSpPr>
          <p:spPr>
            <a:xfrm>
              <a:off x="4323057" y="2347942"/>
              <a:ext cx="2010587" cy="530791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average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distance and minimal distance of training samples,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r</a:t>
              </a:r>
              <a:r>
                <a:rPr lang="en-US" altLang="zh-CN" sz="1200" baseline="-25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1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and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r</a:t>
              </a:r>
              <a:r>
                <a:rPr lang="en-US" altLang="zh-CN" sz="1200" baseline="-25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2</a:t>
              </a:r>
              <a:endParaRPr lang="zh-CN" altLang="en-US" sz="1200" i="1" baseline="-25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3" name="圆角矩形 42"/>
            <p:cNvSpPr/>
            <p:nvPr/>
          </p:nvSpPr>
          <p:spPr>
            <a:xfrm>
              <a:off x="23853" y="3199408"/>
              <a:ext cx="1942013" cy="4872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</a:t>
              </a:r>
              <a:r>
                <a:rPr lang="en-US" altLang="zh-CN" sz="12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w</a:t>
              </a:r>
              <a:r>
                <a:rPr lang="en-US" altLang="zh-CN" sz="1200" i="1" baseline="-25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</a:t>
              </a:r>
              <a:r>
                <a:rPr lang="en-US" altLang="zh-CN" sz="1200" i="1" baseline="30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global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based on global error measurement</a:t>
              </a:r>
              <a:endParaRPr lang="zh-CN" altLang="en-US" sz="1200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4" name="圆角矩形 43"/>
            <p:cNvSpPr/>
            <p:nvPr/>
          </p:nvSpPr>
          <p:spPr>
            <a:xfrm>
              <a:off x="2168792" y="3199408"/>
              <a:ext cx="1917789" cy="4872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w</a:t>
              </a:r>
              <a:r>
                <a:rPr lang="en-US" altLang="zh-CN" sz="1200" i="1" baseline="-25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</a:t>
              </a:r>
              <a:r>
                <a:rPr lang="en-US" altLang="zh-CN" sz="1200" i="1" baseline="30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epv</a:t>
              </a:r>
              <a:r>
                <a:rPr lang="en-US" altLang="zh-CN" sz="1200" i="1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based on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local 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error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measurement</a:t>
              </a:r>
              <a:endParaRPr lang="zh-CN" altLang="en-US" sz="1200" b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45" name="圆角矩形 44"/>
            <p:cNvSpPr/>
            <p:nvPr/>
          </p:nvSpPr>
          <p:spPr>
            <a:xfrm>
              <a:off x="2180357" y="2347942"/>
              <a:ext cx="1894659" cy="5307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average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distance between  </a:t>
              </a:r>
              <a:r>
                <a:rPr lang="en-US" altLang="zh-CN" sz="1200" b="1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x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and </a:t>
              </a:r>
              <a:r>
                <a:rPr lang="en-US" altLang="zh-CN" sz="1200" b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X,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r</a:t>
              </a:r>
              <a:endParaRPr lang="zh-CN" altLang="en-US" sz="1200" b="1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46" name="直接箭头连接符 45"/>
            <p:cNvCxnSpPr>
              <a:stCxn id="40" idx="2"/>
              <a:endCxn id="41" idx="0"/>
            </p:cNvCxnSpPr>
            <p:nvPr/>
          </p:nvCxnSpPr>
          <p:spPr>
            <a:xfrm flipH="1">
              <a:off x="994860" y="1973713"/>
              <a:ext cx="2132827" cy="37422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箭头连接符 46"/>
            <p:cNvCxnSpPr>
              <a:stCxn id="40" idx="2"/>
              <a:endCxn id="42" idx="0"/>
            </p:cNvCxnSpPr>
            <p:nvPr/>
          </p:nvCxnSpPr>
          <p:spPr>
            <a:xfrm>
              <a:off x="3127687" y="1973713"/>
              <a:ext cx="2200664" cy="37422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箭头连接符 47"/>
            <p:cNvCxnSpPr/>
            <p:nvPr/>
          </p:nvCxnSpPr>
          <p:spPr>
            <a:xfrm>
              <a:off x="994859" y="2878733"/>
              <a:ext cx="0" cy="3206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/>
            <p:cNvCxnSpPr>
              <a:stCxn id="41" idx="2"/>
              <a:endCxn id="44" idx="0"/>
            </p:cNvCxnSpPr>
            <p:nvPr/>
          </p:nvCxnSpPr>
          <p:spPr>
            <a:xfrm>
              <a:off x="994860" y="2878732"/>
              <a:ext cx="2132827" cy="3206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箭头连接符 49"/>
            <p:cNvCxnSpPr/>
            <p:nvPr/>
          </p:nvCxnSpPr>
          <p:spPr>
            <a:xfrm>
              <a:off x="3127686" y="2878733"/>
              <a:ext cx="0" cy="3206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箭头连接符 50"/>
            <p:cNvCxnSpPr/>
            <p:nvPr/>
          </p:nvCxnSpPr>
          <p:spPr>
            <a:xfrm>
              <a:off x="5328350" y="2878733"/>
              <a:ext cx="0" cy="3206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圆角矩形 51"/>
            <p:cNvSpPr/>
            <p:nvPr/>
          </p:nvSpPr>
          <p:spPr>
            <a:xfrm>
              <a:off x="4221388" y="3199408"/>
              <a:ext cx="2213925" cy="4872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en-US" sz="12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lculate weight control parameter based </a:t>
              </a:r>
              <a:r>
                <a:rPr lang="en-US" sz="12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distances</a:t>
              </a:r>
              <a:r>
                <a:rPr lang="en-US" sz="1200" baseline="-25000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US" altLang="zh-CN" sz="14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λ</a:t>
              </a:r>
              <a:r>
                <a:rPr lang="zh-CN" altLang="en-US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    </a:t>
              </a:r>
              <a:endParaRPr lang="zh-CN" altLang="en-US" sz="1600" b="1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53" name="直接箭头连接符 52"/>
            <p:cNvCxnSpPr>
              <a:stCxn id="40" idx="2"/>
            </p:cNvCxnSpPr>
            <p:nvPr/>
          </p:nvCxnSpPr>
          <p:spPr>
            <a:xfrm>
              <a:off x="3127687" y="1973713"/>
              <a:ext cx="0" cy="3857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箭头连接符 53"/>
            <p:cNvCxnSpPr>
              <a:stCxn id="38" idx="4"/>
            </p:cNvCxnSpPr>
            <p:nvPr/>
          </p:nvCxnSpPr>
          <p:spPr>
            <a:xfrm>
              <a:off x="3127686" y="374141"/>
              <a:ext cx="1" cy="30056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箭头连接符 54"/>
            <p:cNvCxnSpPr/>
            <p:nvPr/>
          </p:nvCxnSpPr>
          <p:spPr>
            <a:xfrm>
              <a:off x="3127686" y="1118847"/>
              <a:ext cx="0" cy="28172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直接箭头连接符 55"/>
            <p:cNvCxnSpPr>
              <a:stCxn id="45" idx="2"/>
              <a:endCxn id="52" idx="0"/>
            </p:cNvCxnSpPr>
            <p:nvPr/>
          </p:nvCxnSpPr>
          <p:spPr>
            <a:xfrm>
              <a:off x="3127687" y="2878732"/>
              <a:ext cx="2200664" cy="32067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圆角矩形 56"/>
            <p:cNvSpPr/>
            <p:nvPr/>
          </p:nvSpPr>
          <p:spPr>
            <a:xfrm>
              <a:off x="2481073" y="4047232"/>
              <a:ext cx="1293226" cy="487290"/>
            </a:xfrm>
            <a:prstGeom prst="round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initial weight</a:t>
              </a:r>
              <a:r>
                <a:rPr lang="en-US" altLang="zh-CN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,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2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w</a:t>
              </a:r>
              <a:r>
                <a:rPr lang="en-US" altLang="zh-CN" sz="1200" i="1" baseline="-25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</a:t>
              </a:r>
              <a:r>
                <a:rPr lang="en-US" altLang="zh-CN" sz="1200" i="1" baseline="30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nitial</a:t>
              </a:r>
              <a:endParaRPr lang="zh-CN" altLang="en-US" sz="1200" b="1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58" name="直接箭头连接符 57"/>
            <p:cNvCxnSpPr>
              <a:stCxn id="43" idx="2"/>
              <a:endCxn id="57" idx="0"/>
            </p:cNvCxnSpPr>
            <p:nvPr/>
          </p:nvCxnSpPr>
          <p:spPr>
            <a:xfrm>
              <a:off x="994860" y="3686698"/>
              <a:ext cx="2132826" cy="36053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箭头连接符 58"/>
            <p:cNvCxnSpPr>
              <a:stCxn id="52" idx="2"/>
              <a:endCxn id="57" idx="0"/>
            </p:cNvCxnSpPr>
            <p:nvPr/>
          </p:nvCxnSpPr>
          <p:spPr>
            <a:xfrm flipH="1">
              <a:off x="3127686" y="3686698"/>
              <a:ext cx="2200665" cy="36053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接箭头连接符 59"/>
            <p:cNvCxnSpPr>
              <a:endCxn id="57" idx="0"/>
            </p:cNvCxnSpPr>
            <p:nvPr/>
          </p:nvCxnSpPr>
          <p:spPr>
            <a:xfrm flipH="1">
              <a:off x="3127686" y="3686698"/>
              <a:ext cx="2" cy="36053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圆角矩形 60"/>
            <p:cNvSpPr/>
            <p:nvPr/>
          </p:nvSpPr>
          <p:spPr>
            <a:xfrm>
              <a:off x="4456996" y="4459136"/>
              <a:ext cx="1742709" cy="4872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</a:t>
              </a:r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eight adjustment </a:t>
              </a:r>
              <a:r>
                <a:rPr lang="en-US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ctor,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α</a:t>
              </a:r>
              <a:endParaRPr lang="zh-CN" altLang="en-US" sz="1200" b="1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62" name="肘形连接符 61"/>
            <p:cNvCxnSpPr>
              <a:stCxn id="63" idx="3"/>
              <a:endCxn id="61" idx="3"/>
            </p:cNvCxnSpPr>
            <p:nvPr/>
          </p:nvCxnSpPr>
          <p:spPr>
            <a:xfrm flipH="1">
              <a:off x="6199705" y="1682115"/>
              <a:ext cx="34127" cy="3020666"/>
            </a:xfrm>
            <a:prstGeom prst="bentConnector3">
              <a:avLst>
                <a:gd name="adj1" fmla="val -669851"/>
              </a:avLst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圆角矩形 62"/>
            <p:cNvSpPr/>
            <p:nvPr/>
          </p:nvSpPr>
          <p:spPr>
            <a:xfrm>
              <a:off x="4393580" y="1344914"/>
              <a:ext cx="1840252" cy="674402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distances of </a:t>
              </a:r>
              <a:r>
                <a:rPr lang="en-US" altLang="zh-CN" sz="1200" b="1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x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 to its two nearby training sample,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d</a:t>
              </a:r>
              <a:r>
                <a:rPr lang="en-US" altLang="zh-CN" sz="1200" baseline="-25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1 </a:t>
              </a:r>
              <a:r>
                <a:rPr lang="en-US" altLang="zh-CN" sz="12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and </a:t>
              </a:r>
              <a:r>
                <a:rPr lang="en-US" altLang="zh-CN" sz="1200" i="1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d</a:t>
              </a:r>
              <a:r>
                <a:rPr lang="en-US" altLang="zh-CN" sz="1200" baseline="-25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2</a:t>
              </a:r>
              <a:endParaRPr lang="zh-CN" altLang="en-US" sz="1200" baseline="-25000" dirty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sp>
          <p:nvSpPr>
            <p:cNvPr id="64" name="圆角矩形 63"/>
            <p:cNvSpPr/>
            <p:nvPr/>
          </p:nvSpPr>
          <p:spPr>
            <a:xfrm>
              <a:off x="2481073" y="4839397"/>
              <a:ext cx="1293226" cy="48729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Calculate </a:t>
              </a:r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final weight, </a:t>
              </a:r>
              <a:r>
                <a:rPr lang="en-US" altLang="zh-CN" sz="1400" i="1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w</a:t>
              </a:r>
              <a:r>
                <a:rPr lang="en-US" altLang="zh-CN" sz="1400" i="1" baseline="-25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i</a:t>
              </a:r>
              <a:r>
                <a:rPr lang="en-US" altLang="zh-CN" sz="1400" i="1" baseline="30000" dirty="0" err="1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final</a:t>
              </a:r>
              <a:endParaRPr lang="zh-CN" altLang="en-US" sz="1600" b="1" i="1" baseline="30000" dirty="0" smtClean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65" name="直接箭头连接符 64"/>
            <p:cNvCxnSpPr>
              <a:endCxn id="64" idx="0"/>
            </p:cNvCxnSpPr>
            <p:nvPr/>
          </p:nvCxnSpPr>
          <p:spPr>
            <a:xfrm>
              <a:off x="3127686" y="4534522"/>
              <a:ext cx="0" cy="3048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箭头连接符 65"/>
            <p:cNvCxnSpPr>
              <a:stCxn id="61" idx="1"/>
            </p:cNvCxnSpPr>
            <p:nvPr/>
          </p:nvCxnSpPr>
          <p:spPr>
            <a:xfrm flipH="1">
              <a:off x="3127686" y="4702781"/>
              <a:ext cx="132931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椭圆 66"/>
            <p:cNvSpPr/>
            <p:nvPr/>
          </p:nvSpPr>
          <p:spPr>
            <a:xfrm>
              <a:off x="2744509" y="5639515"/>
              <a:ext cx="766354" cy="287383"/>
            </a:xfrm>
            <a:prstGeom prst="ellipse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4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楷体" panose="02010609060101010101" pitchFamily="49" charset="-122"/>
                  <a:cs typeface="Times New Roman" panose="02020603050405020304" pitchFamily="18" charset="0"/>
                </a:rPr>
                <a:t>end</a:t>
              </a:r>
              <a:endParaRPr lang="zh-CN" altLang="en-US" sz="1400" dirty="0">
                <a:solidFill>
                  <a:schemeClr val="tx1"/>
                </a:solidFill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endParaRPr>
            </a:p>
          </p:txBody>
        </p:sp>
        <p:cxnSp>
          <p:nvCxnSpPr>
            <p:cNvPr id="68" name="直接箭头连接符 67"/>
            <p:cNvCxnSpPr>
              <a:endCxn id="67" idx="0"/>
            </p:cNvCxnSpPr>
            <p:nvPr/>
          </p:nvCxnSpPr>
          <p:spPr>
            <a:xfrm>
              <a:off x="3127686" y="5326687"/>
              <a:ext cx="0" cy="31282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箭头连接符 68"/>
            <p:cNvCxnSpPr>
              <a:endCxn id="63" idx="1"/>
            </p:cNvCxnSpPr>
            <p:nvPr/>
          </p:nvCxnSpPr>
          <p:spPr>
            <a:xfrm flipV="1">
              <a:off x="4098693" y="1682115"/>
              <a:ext cx="294887" cy="2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793167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</TotalTime>
  <Words>105</Words>
  <Application>Microsoft Office PowerPoint</Application>
  <PresentationFormat>自定义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楷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>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User</dc:creator>
  <cp:lastModifiedBy>User</cp:lastModifiedBy>
  <cp:revision>19</cp:revision>
  <dcterms:created xsi:type="dcterms:W3CDTF">2023-06-10T11:39:45Z</dcterms:created>
  <dcterms:modified xsi:type="dcterms:W3CDTF">2023-07-12T03:34:14Z</dcterms:modified>
</cp:coreProperties>
</file>